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9906000" type="A4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4536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4156" y="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e-IL" smtClean="0"/>
              <a:t>לחץ כדי לערוך סגנון כותרת משנה של תבנית בסיס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42385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57926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80745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64988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751375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22587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50445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80118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964224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27105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e-IL" smtClean="0"/>
              <a:t>לחץ על הסמל כדי להוסיף תמונה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04943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e-IL" smtClean="0"/>
              <a:t>לחץ כדי לערוך סגנון כותרת של תבנית בסיס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22102-17BF-44BC-8CE9-F5420CDD7C55}" type="datetimeFigureOut">
              <a:rPr lang="he-IL" smtClean="0"/>
              <a:t>כ"ד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2E5FBD-CBCF-4FA2-ABDC-E7C61142C38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605333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מלבן 3"/>
          <p:cNvSpPr/>
          <p:nvPr/>
        </p:nvSpPr>
        <p:spPr>
          <a:xfrm>
            <a:off x="354529" y="540902"/>
            <a:ext cx="6183003" cy="116711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Figure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4.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ell potency of fresh CAR T from day 10 (final product) and cryopreserved CAR T cells from day 6 (thawed 4 days later)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determined by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FNγ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ecretion after co-culture with CD19 expressing target cell lines (NALM-6, CD19-K562) and negative cell line (CCRL-CEM).</a:t>
            </a:r>
          </a:p>
        </p:txBody>
      </p:sp>
      <p:pic>
        <p:nvPicPr>
          <p:cNvPr id="5" name="תמונה 4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9000" y="1787397"/>
            <a:ext cx="3240000" cy="23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3973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ערכת נושא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ערכת נושא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ערכת נושא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</TotalTime>
  <Words>56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She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יצחקי אורית, דר</dc:creator>
  <cp:lastModifiedBy>User</cp:lastModifiedBy>
  <cp:revision>10</cp:revision>
  <dcterms:created xsi:type="dcterms:W3CDTF">2022-09-18T07:12:22Z</dcterms:created>
  <dcterms:modified xsi:type="dcterms:W3CDTF">2022-09-20T09:44:46Z</dcterms:modified>
</cp:coreProperties>
</file>